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1" r:id="rId3"/>
    <p:sldId id="262" r:id="rId4"/>
    <p:sldId id="263" r:id="rId5"/>
    <p:sldId id="264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0759" autoAdjust="0"/>
  </p:normalViewPr>
  <p:slideViewPr>
    <p:cSldViewPr snapToGrid="0" showGuides="1">
      <p:cViewPr varScale="1">
        <p:scale>
          <a:sx n="63" d="100"/>
          <a:sy n="63" d="100"/>
        </p:scale>
        <p:origin x="1382" y="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康 大野" userId="289040ba27705a35" providerId="LiveId" clId="{884A14B0-B003-40F2-B90D-2B8E829F9E2F}"/>
    <pc:docChg chg="custSel delSld modSld">
      <pc:chgData name="雄康 大野" userId="289040ba27705a35" providerId="LiveId" clId="{884A14B0-B003-40F2-B90D-2B8E829F9E2F}" dt="2024-10-17T05:20:28.570" v="103" actId="20577"/>
      <pc:docMkLst>
        <pc:docMk/>
      </pc:docMkLst>
      <pc:sldChg chg="del">
        <pc:chgData name="雄康 大野" userId="289040ba27705a35" providerId="LiveId" clId="{884A14B0-B003-40F2-B90D-2B8E829F9E2F}" dt="2024-09-21T23:41:44.552" v="0" actId="47"/>
        <pc:sldMkLst>
          <pc:docMk/>
          <pc:sldMk cId="3092251034" sldId="259"/>
        </pc:sldMkLst>
      </pc:sldChg>
      <pc:sldChg chg="modSp mod modNotesTx">
        <pc:chgData name="雄康 大野" userId="289040ba27705a35" providerId="LiveId" clId="{884A14B0-B003-40F2-B90D-2B8E829F9E2F}" dt="2024-10-17T05:20:28.570" v="103" actId="20577"/>
        <pc:sldMkLst>
          <pc:docMk/>
          <pc:sldMk cId="716265052" sldId="260"/>
        </pc:sldMkLst>
        <pc:graphicFrameChg chg="modGraphic">
          <ac:chgData name="雄康 大野" userId="289040ba27705a35" providerId="LiveId" clId="{884A14B0-B003-40F2-B90D-2B8E829F9E2F}" dt="2024-09-22T21:49:34.157" v="37" actId="20577"/>
          <ac:graphicFrameMkLst>
            <pc:docMk/>
            <pc:sldMk cId="716265052" sldId="260"/>
            <ac:graphicFrameMk id="3" creationId="{5EBD4749-247B-0BD1-04CD-EB5826A00B62}"/>
          </ac:graphicFrameMkLst>
        </pc:graphicFrameChg>
      </pc:sldChg>
      <pc:sldChg chg="modSp mod modNotesTx">
        <pc:chgData name="雄康 大野" userId="289040ba27705a35" providerId="LiveId" clId="{884A14B0-B003-40F2-B90D-2B8E829F9E2F}" dt="2024-09-22T21:52:39.084" v="63"/>
        <pc:sldMkLst>
          <pc:docMk/>
          <pc:sldMk cId="1407430057" sldId="261"/>
        </pc:sldMkLst>
        <pc:graphicFrameChg chg="mod modGraphic">
          <ac:chgData name="雄康 大野" userId="289040ba27705a35" providerId="LiveId" clId="{884A14B0-B003-40F2-B90D-2B8E829F9E2F}" dt="2024-09-22T21:49:46.204" v="41" actId="20577"/>
          <ac:graphicFrameMkLst>
            <pc:docMk/>
            <pc:sldMk cId="1407430057" sldId="261"/>
            <ac:graphicFrameMk id="3" creationId="{5EBD4749-247B-0BD1-04CD-EB5826A00B62}"/>
          </ac:graphicFrameMkLst>
        </pc:graphicFrameChg>
      </pc:sldChg>
      <pc:sldChg chg="modSp mod modNotesTx">
        <pc:chgData name="雄康 大野" userId="289040ba27705a35" providerId="LiveId" clId="{884A14B0-B003-40F2-B90D-2B8E829F9E2F}" dt="2024-09-22T21:53:06.630" v="99" actId="1035"/>
        <pc:sldMkLst>
          <pc:docMk/>
          <pc:sldMk cId="1896302480" sldId="262"/>
        </pc:sldMkLst>
        <pc:graphicFrameChg chg="mod modGraphic">
          <ac:chgData name="雄康 大野" userId="289040ba27705a35" providerId="LiveId" clId="{884A14B0-B003-40F2-B90D-2B8E829F9E2F}" dt="2024-09-22T21:50:00.096" v="45" actId="20577"/>
          <ac:graphicFrameMkLst>
            <pc:docMk/>
            <pc:sldMk cId="1896302480" sldId="262"/>
            <ac:graphicFrameMk id="3" creationId="{5EBD4749-247B-0BD1-04CD-EB5826A00B62}"/>
          </ac:graphicFrameMkLst>
        </pc:graphicFrameChg>
        <pc:graphicFrameChg chg="mod">
          <ac:chgData name="雄康 大野" userId="289040ba27705a35" providerId="LiveId" clId="{884A14B0-B003-40F2-B90D-2B8E829F9E2F}" dt="2024-09-22T21:53:06.630" v="99" actId="1035"/>
          <ac:graphicFrameMkLst>
            <pc:docMk/>
            <pc:sldMk cId="1896302480" sldId="262"/>
            <ac:graphicFrameMk id="7" creationId="{D14478D4-E6C5-C657-17D3-91F56BCB75F6}"/>
          </ac:graphicFrameMkLst>
        </pc:graphicFrameChg>
      </pc:sldChg>
      <pc:sldChg chg="modSp mod">
        <pc:chgData name="雄康 大野" userId="289040ba27705a35" providerId="LiveId" clId="{884A14B0-B003-40F2-B90D-2B8E829F9E2F}" dt="2024-09-22T21:50:08.822" v="49" actId="20577"/>
        <pc:sldMkLst>
          <pc:docMk/>
          <pc:sldMk cId="474960916" sldId="263"/>
        </pc:sldMkLst>
        <pc:graphicFrameChg chg="mod modGraphic">
          <ac:chgData name="雄康 大野" userId="289040ba27705a35" providerId="LiveId" clId="{884A14B0-B003-40F2-B90D-2B8E829F9E2F}" dt="2024-09-22T21:50:08.822" v="49" actId="20577"/>
          <ac:graphicFrameMkLst>
            <pc:docMk/>
            <pc:sldMk cId="474960916" sldId="263"/>
            <ac:graphicFrameMk id="3" creationId="{5EBD4749-247B-0BD1-04CD-EB5826A00B62}"/>
          </ac:graphicFrameMkLst>
        </pc:graphicFrameChg>
      </pc:sldChg>
      <pc:sldChg chg="modSp mod">
        <pc:chgData name="雄康 大野" userId="289040ba27705a35" providerId="LiveId" clId="{884A14B0-B003-40F2-B90D-2B8E829F9E2F}" dt="2024-09-22T21:50:20.030" v="53" actId="20577"/>
        <pc:sldMkLst>
          <pc:docMk/>
          <pc:sldMk cId="3195160274" sldId="264"/>
        </pc:sldMkLst>
        <pc:graphicFrameChg chg="mod modGraphic">
          <ac:chgData name="雄康 大野" userId="289040ba27705a35" providerId="LiveId" clId="{884A14B0-B003-40F2-B90D-2B8E829F9E2F}" dt="2024-09-22T21:50:20.030" v="53" actId="20577"/>
          <ac:graphicFrameMkLst>
            <pc:docMk/>
            <pc:sldMk cId="3195160274" sldId="264"/>
            <ac:graphicFrameMk id="3" creationId="{5EBD4749-247B-0BD1-04CD-EB5826A00B62}"/>
          </ac:graphicFrameMkLst>
        </pc:graphicFrameChg>
      </pc:sldChg>
    </pc:docChg>
  </pc:docChgLst>
  <pc:docChgLst>
    <pc:chgData name="雄康 大野" userId="289040ba27705a35" providerId="LiveId" clId="{B386BD37-085D-4477-904B-1156E63113D7}"/>
    <pc:docChg chg="undo custSel addSld delSld modSld">
      <pc:chgData name="雄康 大野" userId="289040ba27705a35" providerId="LiveId" clId="{B386BD37-085D-4477-904B-1156E63113D7}" dt="2024-07-30T13:56:59.669" v="888" actId="14734"/>
      <pc:docMkLst>
        <pc:docMk/>
      </pc:docMkLst>
      <pc:sldChg chg="del">
        <pc:chgData name="雄康 大野" userId="289040ba27705a35" providerId="LiveId" clId="{B386BD37-085D-4477-904B-1156E63113D7}" dt="2024-07-30T02:54:31.581" v="122" actId="47"/>
        <pc:sldMkLst>
          <pc:docMk/>
          <pc:sldMk cId="1480799046" sldId="257"/>
        </pc:sldMkLst>
      </pc:sldChg>
      <pc:sldChg chg="del">
        <pc:chgData name="雄康 大野" userId="289040ba27705a35" providerId="LiveId" clId="{B386BD37-085D-4477-904B-1156E63113D7}" dt="2024-07-30T02:54:30.859" v="121" actId="47"/>
        <pc:sldMkLst>
          <pc:docMk/>
          <pc:sldMk cId="3967253686" sldId="258"/>
        </pc:sldMkLst>
      </pc:sldChg>
      <pc:sldChg chg="addSp delSp modSp new mod">
        <pc:chgData name="雄康 大野" userId="289040ba27705a35" providerId="LiveId" clId="{B386BD37-085D-4477-904B-1156E63113D7}" dt="2024-07-30T13:55:12.316" v="881"/>
        <pc:sldMkLst>
          <pc:docMk/>
          <pc:sldMk cId="3092251034" sldId="259"/>
        </pc:sldMkLst>
        <pc:spChg chg="del">
          <ac:chgData name="雄康 大野" userId="289040ba27705a35" providerId="LiveId" clId="{B386BD37-085D-4477-904B-1156E63113D7}" dt="2024-07-29T13:44:08.832" v="1" actId="478"/>
          <ac:spMkLst>
            <pc:docMk/>
            <pc:sldMk cId="3092251034" sldId="259"/>
            <ac:spMk id="2" creationId="{49348D47-AC79-9151-9142-3F2402A97985}"/>
          </ac:spMkLst>
        </pc:spChg>
        <pc:spChg chg="del">
          <ac:chgData name="雄康 大野" userId="289040ba27705a35" providerId="LiveId" clId="{B386BD37-085D-4477-904B-1156E63113D7}" dt="2024-07-29T13:44:11.370" v="2" actId="478"/>
          <ac:spMkLst>
            <pc:docMk/>
            <pc:sldMk cId="3092251034" sldId="259"/>
            <ac:spMk id="3" creationId="{298E0BB6-CE32-0C2A-B4A3-DDC40CE29E2C}"/>
          </ac:spMkLst>
        </pc:spChg>
        <pc:spChg chg="add mod">
          <ac:chgData name="雄康 大野" userId="289040ba27705a35" providerId="LiveId" clId="{B386BD37-085D-4477-904B-1156E63113D7}" dt="2024-07-30T13:04:55.650" v="545" actId="14100"/>
          <ac:spMkLst>
            <pc:docMk/>
            <pc:sldMk cId="3092251034" sldId="259"/>
            <ac:spMk id="4" creationId="{A658390F-1A9D-E10B-3767-663B1E99886C}"/>
          </ac:spMkLst>
        </pc:spChg>
        <pc:spChg chg="add mod">
          <ac:chgData name="雄康 大野" userId="289040ba27705a35" providerId="LiveId" clId="{B386BD37-085D-4477-904B-1156E63113D7}" dt="2024-07-30T02:54:00.058" v="107" actId="1076"/>
          <ac:spMkLst>
            <pc:docMk/>
            <pc:sldMk cId="3092251034" sldId="259"/>
            <ac:spMk id="5" creationId="{FC38F542-2955-D241-B3FE-C076188842B5}"/>
          </ac:spMkLst>
        </pc:spChg>
        <pc:spChg chg="add mod">
          <ac:chgData name="雄康 大野" userId="289040ba27705a35" providerId="LiveId" clId="{B386BD37-085D-4477-904B-1156E63113D7}" dt="2024-07-30T02:54:16.058" v="120" actId="1035"/>
          <ac:spMkLst>
            <pc:docMk/>
            <pc:sldMk cId="3092251034" sldId="259"/>
            <ac:spMk id="6" creationId="{FB8B5A46-9885-2C61-FB49-6AEF8092A223}"/>
          </ac:spMkLst>
        </pc:spChg>
        <pc:graphicFrameChg chg="add mod">
          <ac:chgData name="雄康 大野" userId="289040ba27705a35" providerId="LiveId" clId="{B386BD37-085D-4477-904B-1156E63113D7}" dt="2024-07-30T02:58:11.651" v="265" actId="1036"/>
          <ac:graphicFrameMkLst>
            <pc:docMk/>
            <pc:sldMk cId="3092251034" sldId="259"/>
            <ac:graphicFrameMk id="2" creationId="{215DFE23-E669-4B1C-4F96-EDB4FE7D9E7C}"/>
          </ac:graphicFrameMkLst>
        </pc:graphicFrameChg>
        <pc:graphicFrameChg chg="add mod modGraphic">
          <ac:chgData name="雄康 大野" userId="289040ba27705a35" providerId="LiveId" clId="{B386BD37-085D-4477-904B-1156E63113D7}" dt="2024-07-30T13:55:12.316" v="881"/>
          <ac:graphicFrameMkLst>
            <pc:docMk/>
            <pc:sldMk cId="3092251034" sldId="259"/>
            <ac:graphicFrameMk id="3" creationId="{5EBD4749-247B-0BD1-04CD-EB5826A00B62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23.063" v="882"/>
        <pc:sldMkLst>
          <pc:docMk/>
          <pc:sldMk cId="716265052" sldId="260"/>
        </pc:sldMkLst>
        <pc:spChg chg="mod">
          <ac:chgData name="雄康 大野" userId="289040ba27705a35" providerId="LiveId" clId="{B386BD37-085D-4477-904B-1156E63113D7}" dt="2024-07-30T13:04:40.551" v="543" actId="14100"/>
          <ac:spMkLst>
            <pc:docMk/>
            <pc:sldMk cId="716265052" sldId="260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02:55:06.857" v="124" actId="478"/>
          <ac:graphicFrameMkLst>
            <pc:docMk/>
            <pc:sldMk cId="716265052" sldId="260"/>
            <ac:graphicFrameMk id="2" creationId="{215DFE23-E669-4B1C-4F96-EDB4FE7D9E7C}"/>
          </ac:graphicFrameMkLst>
        </pc:graphicFrameChg>
        <pc:graphicFrameChg chg="mod modGraphic">
          <ac:chgData name="雄康 大野" userId="289040ba27705a35" providerId="LiveId" clId="{B386BD37-085D-4477-904B-1156E63113D7}" dt="2024-07-30T13:55:23.063" v="882"/>
          <ac:graphicFrameMkLst>
            <pc:docMk/>
            <pc:sldMk cId="716265052" sldId="260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02:57:49.651" v="248" actId="1035"/>
          <ac:graphicFrameMkLst>
            <pc:docMk/>
            <pc:sldMk cId="716265052" sldId="260"/>
            <ac:graphicFrameMk id="7" creationId="{F8986106-328D-79B7-BAB8-2EE68F2FC40A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34.510" v="883"/>
        <pc:sldMkLst>
          <pc:docMk/>
          <pc:sldMk cId="1407430057" sldId="261"/>
        </pc:sldMkLst>
        <pc:spChg chg="mod">
          <ac:chgData name="雄康 大野" userId="289040ba27705a35" providerId="LiveId" clId="{B386BD37-085D-4477-904B-1156E63113D7}" dt="2024-07-30T13:05:09.966" v="547" actId="14100"/>
          <ac:spMkLst>
            <pc:docMk/>
            <pc:sldMk cId="1407430057" sldId="261"/>
            <ac:spMk id="4" creationId="{A658390F-1A9D-E10B-3767-663B1E99886C}"/>
          </ac:spMkLst>
        </pc:spChg>
        <pc:graphicFrameChg chg="add mod">
          <ac:chgData name="雄康 大野" userId="289040ba27705a35" providerId="LiveId" clId="{B386BD37-085D-4477-904B-1156E63113D7}" dt="2024-07-30T12:04:59.170" v="296" actId="1076"/>
          <ac:graphicFrameMkLst>
            <pc:docMk/>
            <pc:sldMk cId="1407430057" sldId="261"/>
            <ac:graphicFrameMk id="2" creationId="{EA696120-EA6F-715E-9876-562C70D41F5D}"/>
          </ac:graphicFrameMkLst>
        </pc:graphicFrameChg>
        <pc:graphicFrameChg chg="mod modGraphic">
          <ac:chgData name="雄康 大野" userId="289040ba27705a35" providerId="LiveId" clId="{B386BD37-085D-4477-904B-1156E63113D7}" dt="2024-07-30T13:55:34.510" v="883"/>
          <ac:graphicFrameMkLst>
            <pc:docMk/>
            <pc:sldMk cId="1407430057" sldId="261"/>
            <ac:graphicFrameMk id="3" creationId="{5EBD4749-247B-0BD1-04CD-EB5826A00B62}"/>
          </ac:graphicFrameMkLst>
        </pc:graphicFrameChg>
        <pc:graphicFrameChg chg="del">
          <ac:chgData name="雄康 大野" userId="289040ba27705a35" providerId="LiveId" clId="{B386BD37-085D-4477-904B-1156E63113D7}" dt="2024-07-30T02:56:50.834" v="166" actId="478"/>
          <ac:graphicFrameMkLst>
            <pc:docMk/>
            <pc:sldMk cId="1407430057" sldId="261"/>
            <ac:graphicFrameMk id="7" creationId="{F8986106-328D-79B7-BAB8-2EE68F2FC40A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5:51.285" v="884"/>
        <pc:sldMkLst>
          <pc:docMk/>
          <pc:sldMk cId="1896302480" sldId="262"/>
        </pc:sldMkLst>
        <pc:spChg chg="mod">
          <ac:chgData name="雄康 大野" userId="289040ba27705a35" providerId="LiveId" clId="{B386BD37-085D-4477-904B-1156E63113D7}" dt="2024-07-30T13:05:25.582" v="549" actId="14100"/>
          <ac:spMkLst>
            <pc:docMk/>
            <pc:sldMk cId="1896302480" sldId="262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12:03:55.076" v="280" actId="478"/>
          <ac:graphicFrameMkLst>
            <pc:docMk/>
            <pc:sldMk cId="1896302480" sldId="262"/>
            <ac:graphicFrameMk id="2" creationId="{EA696120-EA6F-715E-9876-562C70D41F5D}"/>
          </ac:graphicFrameMkLst>
        </pc:graphicFrameChg>
        <pc:graphicFrameChg chg="mod modGraphic">
          <ac:chgData name="雄康 大野" userId="289040ba27705a35" providerId="LiveId" clId="{B386BD37-085D-4477-904B-1156E63113D7}" dt="2024-07-30T13:55:51.285" v="884"/>
          <ac:graphicFrameMkLst>
            <pc:docMk/>
            <pc:sldMk cId="1896302480" sldId="262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12:05:20.944" v="317" actId="1036"/>
          <ac:graphicFrameMkLst>
            <pc:docMk/>
            <pc:sldMk cId="1896302480" sldId="262"/>
            <ac:graphicFrameMk id="7" creationId="{D14478D4-E6C5-C657-17D3-91F56BCB75F6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6:59.669" v="888" actId="14734"/>
        <pc:sldMkLst>
          <pc:docMk/>
          <pc:sldMk cId="474960916" sldId="263"/>
        </pc:sldMkLst>
        <pc:spChg chg="mod">
          <ac:chgData name="雄康 大野" userId="289040ba27705a35" providerId="LiveId" clId="{B386BD37-085D-4477-904B-1156E63113D7}" dt="2024-07-30T13:05:36.563" v="551" actId="14100"/>
          <ac:spMkLst>
            <pc:docMk/>
            <pc:sldMk cId="474960916" sldId="263"/>
            <ac:spMk id="4" creationId="{A658390F-1A9D-E10B-3767-663B1E99886C}"/>
          </ac:spMkLst>
        </pc:spChg>
        <pc:graphicFrameChg chg="add mod">
          <ac:chgData name="雄康 大野" userId="289040ba27705a35" providerId="LiveId" clId="{B386BD37-085D-4477-904B-1156E63113D7}" dt="2024-07-30T12:06:36.716" v="353" actId="1035"/>
          <ac:graphicFrameMkLst>
            <pc:docMk/>
            <pc:sldMk cId="474960916" sldId="263"/>
            <ac:graphicFrameMk id="2" creationId="{F7045346-BA9F-7E25-6CF8-6C7BE6DD92F5}"/>
          </ac:graphicFrameMkLst>
        </pc:graphicFrameChg>
        <pc:graphicFrameChg chg="mod modGraphic">
          <ac:chgData name="雄康 大野" userId="289040ba27705a35" providerId="LiveId" clId="{B386BD37-085D-4477-904B-1156E63113D7}" dt="2024-07-30T13:56:59.669" v="888" actId="14734"/>
          <ac:graphicFrameMkLst>
            <pc:docMk/>
            <pc:sldMk cId="474960916" sldId="263"/>
            <ac:graphicFrameMk id="3" creationId="{5EBD4749-247B-0BD1-04CD-EB5826A00B62}"/>
          </ac:graphicFrameMkLst>
        </pc:graphicFrameChg>
        <pc:graphicFrameChg chg="del">
          <ac:chgData name="雄康 大野" userId="289040ba27705a35" providerId="LiveId" clId="{B386BD37-085D-4477-904B-1156E63113D7}" dt="2024-07-30T12:05:48.825" v="328" actId="478"/>
          <ac:graphicFrameMkLst>
            <pc:docMk/>
            <pc:sldMk cId="474960916" sldId="263"/>
            <ac:graphicFrameMk id="7" creationId="{D14478D4-E6C5-C657-17D3-91F56BCB75F6}"/>
          </ac:graphicFrameMkLst>
        </pc:graphicFrameChg>
      </pc:sldChg>
      <pc:sldChg chg="addSp delSp modSp add mod">
        <pc:chgData name="雄康 大野" userId="289040ba27705a35" providerId="LiveId" clId="{B386BD37-085D-4477-904B-1156E63113D7}" dt="2024-07-30T13:56:42.531" v="886"/>
        <pc:sldMkLst>
          <pc:docMk/>
          <pc:sldMk cId="3195160274" sldId="264"/>
        </pc:sldMkLst>
        <pc:spChg chg="mod">
          <ac:chgData name="雄康 大野" userId="289040ba27705a35" providerId="LiveId" clId="{B386BD37-085D-4477-904B-1156E63113D7}" dt="2024-07-30T13:05:48" v="553" actId="14100"/>
          <ac:spMkLst>
            <pc:docMk/>
            <pc:sldMk cId="3195160274" sldId="264"/>
            <ac:spMk id="4" creationId="{A658390F-1A9D-E10B-3767-663B1E99886C}"/>
          </ac:spMkLst>
        </pc:spChg>
        <pc:graphicFrameChg chg="del">
          <ac:chgData name="雄康 大野" userId="289040ba27705a35" providerId="LiveId" clId="{B386BD37-085D-4477-904B-1156E63113D7}" dt="2024-07-30T12:07:01.670" v="355" actId="478"/>
          <ac:graphicFrameMkLst>
            <pc:docMk/>
            <pc:sldMk cId="3195160274" sldId="264"/>
            <ac:graphicFrameMk id="2" creationId="{F7045346-BA9F-7E25-6CF8-6C7BE6DD92F5}"/>
          </ac:graphicFrameMkLst>
        </pc:graphicFrameChg>
        <pc:graphicFrameChg chg="mod modGraphic">
          <ac:chgData name="雄康 大野" userId="289040ba27705a35" providerId="LiveId" clId="{B386BD37-085D-4477-904B-1156E63113D7}" dt="2024-07-30T13:56:42.531" v="886"/>
          <ac:graphicFrameMkLst>
            <pc:docMk/>
            <pc:sldMk cId="3195160274" sldId="264"/>
            <ac:graphicFrameMk id="3" creationId="{5EBD4749-247B-0BD1-04CD-EB5826A00B62}"/>
          </ac:graphicFrameMkLst>
        </pc:graphicFrameChg>
        <pc:graphicFrameChg chg="add mod">
          <ac:chgData name="雄康 大野" userId="289040ba27705a35" providerId="LiveId" clId="{B386BD37-085D-4477-904B-1156E63113D7}" dt="2024-07-30T12:07:43.160" v="373" actId="1035"/>
          <ac:graphicFrameMkLst>
            <pc:docMk/>
            <pc:sldMk cId="3195160274" sldId="264"/>
            <ac:graphicFrameMk id="7" creationId="{5F43EC09-8CE5-BC92-794A-E8E71D403B90}"/>
          </ac:graphicFrameMkLst>
        </pc:graphicFrameChg>
      </pc:sldChg>
    </pc:docChg>
  </pc:docChgLst>
  <pc:docChgLst>
    <pc:chgData name="雄康 大野" userId="289040ba27705a35" providerId="LiveId" clId="{2C55E1BE-C822-4749-BC07-90ECA1F44377}"/>
    <pc:docChg chg="modSld">
      <pc:chgData name="雄康 大野" userId="289040ba27705a35" providerId="LiveId" clId="{2C55E1BE-C822-4749-BC07-90ECA1F44377}" dt="2024-11-12T11:52:46.567" v="6"/>
      <pc:docMkLst>
        <pc:docMk/>
      </pc:docMkLst>
      <pc:sldChg chg="modNotesTx">
        <pc:chgData name="雄康 大野" userId="289040ba27705a35" providerId="LiveId" clId="{2C55E1BE-C822-4749-BC07-90ECA1F44377}" dt="2024-11-12T11:52:16.427" v="1"/>
        <pc:sldMkLst>
          <pc:docMk/>
          <pc:sldMk cId="716265052" sldId="260"/>
        </pc:sldMkLst>
      </pc:sldChg>
      <pc:sldChg chg="modNotesTx">
        <pc:chgData name="雄康 大野" userId="289040ba27705a35" providerId="LiveId" clId="{2C55E1BE-C822-4749-BC07-90ECA1F44377}" dt="2024-11-12T11:52:36.047" v="3"/>
        <pc:sldMkLst>
          <pc:docMk/>
          <pc:sldMk cId="1407430057" sldId="261"/>
        </pc:sldMkLst>
      </pc:sldChg>
      <pc:sldChg chg="modNotesTx">
        <pc:chgData name="雄康 大野" userId="289040ba27705a35" providerId="LiveId" clId="{2C55E1BE-C822-4749-BC07-90ECA1F44377}" dt="2024-11-12T11:52:40.655" v="4"/>
        <pc:sldMkLst>
          <pc:docMk/>
          <pc:sldMk cId="1896302480" sldId="262"/>
        </pc:sldMkLst>
      </pc:sldChg>
      <pc:sldChg chg="modNotesTx">
        <pc:chgData name="雄康 大野" userId="289040ba27705a35" providerId="LiveId" clId="{2C55E1BE-C822-4749-BC07-90ECA1F44377}" dt="2024-11-12T11:52:43.833" v="5"/>
        <pc:sldMkLst>
          <pc:docMk/>
          <pc:sldMk cId="474960916" sldId="263"/>
        </pc:sldMkLst>
      </pc:sldChg>
      <pc:sldChg chg="modNotesTx">
        <pc:chgData name="雄康 大野" userId="289040ba27705a35" providerId="LiveId" clId="{2C55E1BE-C822-4749-BC07-90ECA1F44377}" dt="2024-11-12T11:52:46.567" v="6"/>
        <pc:sldMkLst>
          <pc:docMk/>
          <pc:sldMk cId="3195160274" sldId="264"/>
        </pc:sldMkLst>
      </pc:sldChg>
    </pc:docChg>
  </pc:docChgLst>
  <pc:docChgLst>
    <pc:chgData name="雄康 大野" userId="289040ba27705a35" providerId="LiveId" clId="{633161D3-CA0C-4066-BCCC-61B791DABA9F}"/>
    <pc:docChg chg="custSel addSld delSld modSld sldOrd">
      <pc:chgData name="雄康 大野" userId="289040ba27705a35" providerId="LiveId" clId="{633161D3-CA0C-4066-BCCC-61B791DABA9F}" dt="2024-07-15T00:26:54.212" v="630" actId="1076"/>
      <pc:docMkLst>
        <pc:docMk/>
      </pc:docMkLst>
      <pc:sldChg chg="addSp delSp modSp del mod">
        <pc:chgData name="雄康 大野" userId="289040ba27705a35" providerId="LiveId" clId="{633161D3-CA0C-4066-BCCC-61B791DABA9F}" dt="2024-07-14T12:06:42.492" v="184" actId="47"/>
        <pc:sldMkLst>
          <pc:docMk/>
          <pc:sldMk cId="3398849434" sldId="256"/>
        </pc:sldMkLst>
        <pc:spChg chg="mod">
          <ac:chgData name="雄康 大野" userId="289040ba27705a35" providerId="LiveId" clId="{633161D3-CA0C-4066-BCCC-61B791DABA9F}" dt="2024-07-14T11:49:00.711" v="62" actId="20577"/>
          <ac:spMkLst>
            <pc:docMk/>
            <pc:sldMk cId="3398849434" sldId="256"/>
            <ac:spMk id="2" creationId="{9741318B-5FDD-00E8-764B-E684EBC99AF4}"/>
          </ac:spMkLst>
        </pc:spChg>
        <pc:spChg chg="mod">
          <ac:chgData name="雄康 大野" userId="289040ba27705a35" providerId="LiveId" clId="{633161D3-CA0C-4066-BCCC-61B791DABA9F}" dt="2024-07-14T11:48:38.780" v="48" actId="20577"/>
          <ac:spMkLst>
            <pc:docMk/>
            <pc:sldMk cId="3398849434" sldId="256"/>
            <ac:spMk id="3" creationId="{F8BBDCE6-5246-4B6C-23D3-E2B958AB9BF1}"/>
          </ac:spMkLst>
        </pc:spChg>
        <pc:graphicFrameChg chg="add del mod">
          <ac:chgData name="雄康 大野" userId="289040ba27705a35" providerId="LiveId" clId="{633161D3-CA0C-4066-BCCC-61B791DABA9F}" dt="2024-07-14T11:42:09.242" v="3" actId="478"/>
          <ac:graphicFrameMkLst>
            <pc:docMk/>
            <pc:sldMk cId="3398849434" sldId="256"/>
            <ac:graphicFrameMk id="4" creationId="{CF9E89EE-4634-C6BB-722C-A017269FB33C}"/>
          </ac:graphicFrameMkLst>
        </pc:graphicFrameChg>
        <pc:graphicFrameChg chg="mod modGraphic">
          <ac:chgData name="雄康 大野" userId="289040ba27705a35" providerId="LiveId" clId="{633161D3-CA0C-4066-BCCC-61B791DABA9F}" dt="2024-07-14T11:54:05.379" v="159" actId="20577"/>
          <ac:graphicFrameMkLst>
            <pc:docMk/>
            <pc:sldMk cId="3398849434" sldId="256"/>
            <ac:graphicFrameMk id="5" creationId="{EF955210-2507-6EC3-420A-01BE20A1E2F6}"/>
          </ac:graphicFrameMkLst>
        </pc:graphicFrameChg>
        <pc:graphicFrameChg chg="del">
          <ac:chgData name="雄康 大野" userId="289040ba27705a35" providerId="LiveId" clId="{633161D3-CA0C-4066-BCCC-61B791DABA9F}" dt="2024-07-14T11:40:31.620" v="0" actId="478"/>
          <ac:graphicFrameMkLst>
            <pc:docMk/>
            <pc:sldMk cId="3398849434" sldId="256"/>
            <ac:graphicFrameMk id="6" creationId="{F298689A-EB9D-DD0D-4A6A-2B403597FF4F}"/>
          </ac:graphicFrameMkLst>
        </pc:graphicFrameChg>
        <pc:graphicFrameChg chg="add mod">
          <ac:chgData name="雄康 大野" userId="289040ba27705a35" providerId="LiveId" clId="{633161D3-CA0C-4066-BCCC-61B791DABA9F}" dt="2024-07-14T11:44:59.057" v="7" actId="14100"/>
          <ac:graphicFrameMkLst>
            <pc:docMk/>
            <pc:sldMk cId="3398849434" sldId="256"/>
            <ac:graphicFrameMk id="7" creationId="{06D58F0F-2EC4-A451-52E3-6AFC545322DB}"/>
          </ac:graphicFrameMkLst>
        </pc:graphicFrameChg>
      </pc:sldChg>
      <pc:sldChg chg="addSp modSp add mod">
        <pc:chgData name="雄康 大野" userId="289040ba27705a35" providerId="LiveId" clId="{633161D3-CA0C-4066-BCCC-61B791DABA9F}" dt="2024-07-14T12:06:31.296" v="182" actId="122"/>
        <pc:sldMkLst>
          <pc:docMk/>
          <pc:sldMk cId="1480799046" sldId="257"/>
        </pc:sldMkLst>
        <pc:spChg chg="add mod">
          <ac:chgData name="雄康 大野" userId="289040ba27705a35" providerId="LiveId" clId="{633161D3-CA0C-4066-BCCC-61B791DABA9F}" dt="2024-07-14T12:06:31.296" v="182" actId="122"/>
          <ac:spMkLst>
            <pc:docMk/>
            <pc:sldMk cId="1480799046" sldId="257"/>
            <ac:spMk id="4" creationId="{ECC4E526-1495-889B-828A-1B060A87892B}"/>
          </ac:spMkLst>
        </pc:spChg>
      </pc:sldChg>
      <pc:sldChg chg="addSp delSp modSp add mod ord">
        <pc:chgData name="雄康 大野" userId="289040ba27705a35" providerId="LiveId" clId="{633161D3-CA0C-4066-BCCC-61B791DABA9F}" dt="2024-07-15T00:26:54.212" v="630" actId="1076"/>
        <pc:sldMkLst>
          <pc:docMk/>
          <pc:sldMk cId="3967253686" sldId="258"/>
        </pc:sldMkLst>
        <pc:spChg chg="mod">
          <ac:chgData name="雄康 大野" userId="289040ba27705a35" providerId="LiveId" clId="{633161D3-CA0C-4066-BCCC-61B791DABA9F}" dt="2024-07-15T00:26:45.045" v="629" actId="1038"/>
          <ac:spMkLst>
            <pc:docMk/>
            <pc:sldMk cId="3967253686" sldId="258"/>
            <ac:spMk id="2" creationId="{9741318B-5FDD-00E8-764B-E684EBC99AF4}"/>
          </ac:spMkLst>
        </pc:spChg>
        <pc:spChg chg="mod">
          <ac:chgData name="雄康 大野" userId="289040ba27705a35" providerId="LiveId" clId="{633161D3-CA0C-4066-BCCC-61B791DABA9F}" dt="2024-07-15T00:26:45.045" v="629" actId="1038"/>
          <ac:spMkLst>
            <pc:docMk/>
            <pc:sldMk cId="3967253686" sldId="258"/>
            <ac:spMk id="3" creationId="{F8BBDCE6-5246-4B6C-23D3-E2B958AB9BF1}"/>
          </ac:spMkLst>
        </pc:spChg>
        <pc:spChg chg="del mod">
          <ac:chgData name="雄康 大野" userId="289040ba27705a35" providerId="LiveId" clId="{633161D3-CA0C-4066-BCCC-61B791DABA9F}" dt="2024-07-15T00:02:04.858" v="306" actId="478"/>
          <ac:spMkLst>
            <pc:docMk/>
            <pc:sldMk cId="3967253686" sldId="258"/>
            <ac:spMk id="4" creationId="{ECC4E526-1495-889B-828A-1B060A87892B}"/>
          </ac:spMkLst>
        </pc:spChg>
        <pc:spChg chg="add mod">
          <ac:chgData name="雄康 大野" userId="289040ba27705a35" providerId="LiveId" clId="{633161D3-CA0C-4066-BCCC-61B791DABA9F}" dt="2024-07-15T00:26:54.212" v="630" actId="1076"/>
          <ac:spMkLst>
            <pc:docMk/>
            <pc:sldMk cId="3967253686" sldId="258"/>
            <ac:spMk id="7" creationId="{83B0FDE6-D68E-3FA2-96BF-8F0709E7A2A4}"/>
          </ac:spMkLst>
        </pc:spChg>
        <pc:graphicFrameChg chg="mod modGraphic">
          <ac:chgData name="雄康 大野" userId="289040ba27705a35" providerId="LiveId" clId="{633161D3-CA0C-4066-BCCC-61B791DABA9F}" dt="2024-07-15T00:26:45.045" v="629" actId="1038"/>
          <ac:graphicFrameMkLst>
            <pc:docMk/>
            <pc:sldMk cId="3967253686" sldId="258"/>
            <ac:graphicFrameMk id="5" creationId="{EF955210-2507-6EC3-420A-01BE20A1E2F6}"/>
          </ac:graphicFrameMkLst>
        </pc:graphicFrameChg>
        <pc:graphicFrameChg chg="add mod">
          <ac:chgData name="雄康 大野" userId="289040ba27705a35" providerId="LiveId" clId="{633161D3-CA0C-4066-BCCC-61B791DABA9F}" dt="2024-07-15T00:26:45.045" v="629" actId="1038"/>
          <ac:graphicFrameMkLst>
            <pc:docMk/>
            <pc:sldMk cId="3967253686" sldId="258"/>
            <ac:graphicFrameMk id="6" creationId="{D5FA6D27-5226-E74A-ABA7-4306F02CEE73}"/>
          </ac:graphicFrameMkLst>
        </pc:graphicFrameChg>
        <pc:graphicFrameChg chg="add del mod">
          <ac:chgData name="雄康 大野" userId="289040ba27705a35" providerId="LiveId" clId="{633161D3-CA0C-4066-BCCC-61B791DABA9F}" dt="2024-07-14T13:25:41.268" v="213" actId="478"/>
          <ac:graphicFrameMkLst>
            <pc:docMk/>
            <pc:sldMk cId="3967253686" sldId="258"/>
            <ac:graphicFrameMk id="6" creationId="{FDCB472E-E0F5-56D4-6C1A-CF7874D79082}"/>
          </ac:graphicFrameMkLst>
        </pc:graphicFrameChg>
        <pc:graphicFrameChg chg="del">
          <ac:chgData name="雄康 大野" userId="289040ba27705a35" providerId="LiveId" clId="{633161D3-CA0C-4066-BCCC-61B791DABA9F}" dt="2024-07-14T12:06:46.172" v="185" actId="478"/>
          <ac:graphicFrameMkLst>
            <pc:docMk/>
            <pc:sldMk cId="3967253686" sldId="258"/>
            <ac:graphicFrameMk id="7" creationId="{06D58F0F-2EC4-A451-52E3-6AFC545322DB}"/>
          </ac:graphicFrameMkLst>
        </pc:graphicFrameChg>
        <pc:graphicFrameChg chg="add del mod">
          <ac:chgData name="雄康 大野" userId="289040ba27705a35" providerId="LiveId" clId="{633161D3-CA0C-4066-BCCC-61B791DABA9F}" dt="2024-07-14T23:58:08.931" v="221" actId="478"/>
          <ac:graphicFrameMkLst>
            <pc:docMk/>
            <pc:sldMk cId="3967253686" sldId="258"/>
            <ac:graphicFrameMk id="8" creationId="{C49C5700-1832-8E94-D74C-7C12DCC79F0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108BCB-97D3-407A-8C52-02B53E360D6D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8D901-7FD4-4A86-A324-C1DAF880C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16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. Subgroup analysis of anatomical severities among study participants: standard vehicle group versus K-car vehicle group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the standard vehicle group.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8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ISS, Injury Severity Score; OR, odds ratio; PS, propensity score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339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. Subgroup analysis of anatomical severities among study participants: standard vehicle group versus K-car vehicle group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the standard vehicle group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ISS, Injury Severity Score; OR, odds ratio; PS, propensity scor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1140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. Subgroup analysis of anatomical severities among study participants: standard vehicle group versus K-car vehicle group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the standard vehicle group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ISS, Injury Severity Score; OR, odds ratio; PS, propensity scor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1081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. Subgroup analysis of anatomical severities among study participants: standard vehicle group versus K-car vehicle group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the standard vehicle group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ISS, Injury Severity Score; OR, odds ratio; PS, propensity scor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54207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Fig. Subgroup analysis of anatomical severities among study participants: standard vehicle group versus K-car vehicle group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ference set was the standard vehicle group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justment, as described in the Methods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confidence interval; ISS, Injury Severity Score; OR, odds ratio; PS, propensity scor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/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8D901-7FD4-4A86-A324-C1DAF880C707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241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A82203-E9C2-79B5-F2A6-296D4F8D83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5351052-E78F-830F-0515-221DE4DD00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0CFA22-6C47-C7E6-FDDB-6658205A1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A359DA-E97E-D4D9-2A24-16FBCA454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87C223-A5ED-255E-C8EB-D17F8BB21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14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6375F9-2687-08FC-6C04-6A3A97B7E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FC6154-758F-E60E-D41E-A09803572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3DA32E-D00F-BDC6-A926-EE2ECCE2B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B97F92-EC27-4530-F6E0-BAA7043A5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39D7C1-FEBB-14CE-B38A-5C60799F5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32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BD99C6-D52B-7B29-CFB1-EF4BAEFC20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407232-A546-A202-0BB7-6DAB37C752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26CB81-CEB8-422F-A65B-D254DDC08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EDA519F-C0CA-D9F0-50EC-FF1A35B4C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E8F942-BB70-E43E-8E4F-5AEBF5245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14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F3B9D8-26FF-F199-2642-2B010356C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D4F9EE-170C-58E0-DA2B-F2B940CD61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59CD7D-10FA-060B-19C2-40193BDBE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562D33-1DFB-922D-01B3-D53AD68F3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C7A3B5-60A7-3E1E-4ED9-2BE696920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02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CA2DD0-3DFA-5A12-4157-8D7934012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FB4CBA-3A76-8B9E-1B5D-B52424583A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87EE3-CA90-1A09-9905-D26E6D952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DB90AA-AB18-532A-DE41-C6B8A551A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F566C1-DEEE-BE3B-DEA1-46014895B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822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70F06C-77DA-03A9-F1A9-5A15F8CDF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319DE7-526C-9A77-E594-81ABB5BBA3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73E100-6E3C-8281-8A48-A03458A329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85C352-6024-A6D3-D363-542AFD7A8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8DE9B7-8BDB-199D-9A3F-D8E565C89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D9A3B0-F8E3-9025-A444-3ED0C56AA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883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E9C443-FF97-123E-BB81-4A2DF1D4C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549A72-62E7-674D-2FEE-6455D0A15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1C33D50-0495-2D67-B41F-EBE9521930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BBED24D-98E3-A923-E5E4-9019A22ED9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2D7C55-A070-D121-C69B-13B6C064F4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504A817-EE13-9FBE-97CF-130C7884B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77C5837-30F3-864E-1593-026B7A0BB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F60BCCA-94C0-29A3-6B35-9F7A3551C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803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DF133C-F6E4-F800-B025-66D4FC11F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C21C2C6-3123-F40C-B1A3-E17552A50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512214A-E282-DA75-9055-CBD2C0A06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D7FCA06-B6A2-B1DD-E490-01E76D6A1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918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B2ED59-B1B5-E131-E608-7AEAD0190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9CE295D-43AE-22D1-873B-502C71FD6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D87208-C3A1-C619-CC74-287DAC8B8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216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94A3EF-1C25-9A1C-FEBA-990B7DD39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34A2FA-1643-010A-91B4-7FFF5B419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BAA302C-2154-F0A5-A263-B09FD34DCF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61A52B-F675-C81C-D816-A76FFF675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449EDD-70E5-84B3-8D7C-0F141DC89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2C0596-AFAA-42FB-0F09-2FAE678DB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3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1E5A36-BBD7-B36D-F0FA-DF36713C7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6BFF112-7257-A6C5-280C-541C76ED62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35CB79-5A1D-779E-3A47-7875D520D5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B7FC8E-FB10-49A8-5743-F0F1D3B3C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5B8CA35-7D46-58CD-7D1A-4839B0A86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032F81-16FE-4B35-EF2B-807EF2A37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03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C5665C6-15FC-5D41-C2EB-F89777471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AECAF7-2FA8-77B2-F5F8-573E043134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A0A6DF-898D-9523-4E12-B2226A6D44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2A334-A298-40B8-BBF4-1B3B99310889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282453-367C-9F1F-9573-92DED5B49E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0CC7D7-B983-2063-A01A-B84E13A371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83DE4-BAF0-43A3-B43C-94A38B6C02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010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0073533"/>
              </p:ext>
            </p:extLst>
          </p:nvPr>
        </p:nvGraphicFramePr>
        <p:xfrm>
          <a:off x="666770" y="947404"/>
          <a:ext cx="6540212" cy="4380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7446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 (1.1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2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 (1.21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6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 (1.3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94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 (1.1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4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 (1.3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8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0" y="387310"/>
            <a:ext cx="7084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ever trauma with ISS&gt;1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F8986106-328D-79B7-BAB8-2EE68F2FC4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2475433"/>
              </p:ext>
            </p:extLst>
          </p:nvPr>
        </p:nvGraphicFramePr>
        <p:xfrm>
          <a:off x="6429308" y="1264396"/>
          <a:ext cx="6540212" cy="58858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F8986106-328D-79B7-BAB8-2EE68F2FC4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29308" y="1264396"/>
                        <a:ext cx="6540212" cy="58858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16265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3604734"/>
              </p:ext>
            </p:extLst>
          </p:nvPr>
        </p:nvGraphicFramePr>
        <p:xfrm>
          <a:off x="666770" y="947404"/>
          <a:ext cx="6540212" cy="4380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7446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 (1.01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.53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(1.12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4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 (1.18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8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 (0.92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6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 (1.2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1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145165" y="414974"/>
            <a:ext cx="6939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IS head or neck 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≧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EA696120-EA6F-715E-9876-562C70D41F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0567835"/>
              </p:ext>
            </p:extLst>
          </p:nvPr>
        </p:nvGraphicFramePr>
        <p:xfrm>
          <a:off x="6404013" y="1251844"/>
          <a:ext cx="6285869" cy="5656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EA696120-EA6F-715E-9876-562C70D41F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04013" y="1251844"/>
                        <a:ext cx="6285869" cy="5656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07430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3731202"/>
              </p:ext>
            </p:extLst>
          </p:nvPr>
        </p:nvGraphicFramePr>
        <p:xfrm>
          <a:off x="666770" y="947404"/>
          <a:ext cx="6540212" cy="44472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64974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(1.04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6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83804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 (1.07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6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 (1.07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60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 (1.0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41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 (1.25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3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205960" y="387310"/>
            <a:ext cx="6878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IS chest 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≧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D14478D4-E6C5-C657-17D3-91F56BCB75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8351246"/>
              </p:ext>
            </p:extLst>
          </p:nvPr>
        </p:nvGraphicFramePr>
        <p:xfrm>
          <a:off x="6301960" y="1337702"/>
          <a:ext cx="6134068" cy="5520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D14478D4-E6C5-C657-17D3-91F56BCB75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01960" y="1337702"/>
                        <a:ext cx="6134068" cy="5520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63024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7956644"/>
              </p:ext>
            </p:extLst>
          </p:nvPr>
        </p:nvGraphicFramePr>
        <p:xfrm>
          <a:off x="666770" y="947404"/>
          <a:ext cx="6540212" cy="4380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7446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 (1.23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9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 (1.3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5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7 (1.45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67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(1.10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7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 (1.23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2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1" y="387310"/>
            <a:ext cx="72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IS abdomen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r pelvic contents 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≧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F7045346-BA9F-7E25-6CF8-6C7BE6DD92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746129"/>
              </p:ext>
            </p:extLst>
          </p:nvPr>
        </p:nvGraphicFramePr>
        <p:xfrm>
          <a:off x="6170044" y="1286257"/>
          <a:ext cx="6401220" cy="5760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F7045346-BA9F-7E25-6CF8-6C7BE6DD92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70044" y="1286257"/>
                        <a:ext cx="6401220" cy="57607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749609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5">
            <a:extLst>
              <a:ext uri="{FF2B5EF4-FFF2-40B4-BE49-F238E27FC236}">
                <a16:creationId xmlns:a16="http://schemas.microsoft.com/office/drawing/2014/main" id="{5EBD4749-247B-0BD1-04CD-EB5826A00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649027"/>
              </p:ext>
            </p:extLst>
          </p:nvPr>
        </p:nvGraphicFramePr>
        <p:xfrm>
          <a:off x="666770" y="947404"/>
          <a:ext cx="6540212" cy="4380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51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37802828"/>
                    </a:ext>
                  </a:extLst>
                </a:gridCol>
                <a:gridCol w="1970752">
                  <a:extLst>
                    <a:ext uri="{9D8B030D-6E8A-4147-A177-3AD203B41FA5}">
                      <a16:colId xmlns:a16="http://schemas.microsoft.com/office/drawing/2014/main" val="3908064049"/>
                    </a:ext>
                  </a:extLst>
                </a:gridCol>
              </a:tblGrid>
              <a:tr h="7446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OR (95% CI)</a:t>
                      </a:r>
                      <a:r>
                        <a:rPr kumimoji="1" lang="en-US" altLang="ja-JP" baseline="30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l coho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3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 (1.12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72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453740"/>
                  </a:ext>
                </a:extLst>
              </a:tr>
              <a:tr h="676375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belt: Belted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5 (1.43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39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71925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bag: Equipped and deployment 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 (1.21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0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ision type: Frontal collisio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5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5 (1.17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80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7819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position: Driver’s sea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9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 (1.33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–</a:t>
                      </a: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8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58390F-1A9D-E10B-3767-663B1E99886C}"/>
              </a:ext>
            </a:extLst>
          </p:cNvPr>
          <p:cNvSpPr txBox="1"/>
          <p:nvPr/>
        </p:nvSpPr>
        <p:spPr>
          <a:xfrm>
            <a:off x="157357" y="387310"/>
            <a:ext cx="69271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IS extremities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r pelvic girdle 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≧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38F542-2955-D241-B3FE-C076188842B5}"/>
              </a:ext>
            </a:extLst>
          </p:cNvPr>
          <p:cNvSpPr txBox="1"/>
          <p:nvPr/>
        </p:nvSpPr>
        <p:spPr>
          <a:xfrm>
            <a:off x="7084554" y="387310"/>
            <a:ext cx="2286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K-car vehicle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B8B5A46-9885-2C61-FB49-6AEF8092A223}"/>
              </a:ext>
            </a:extLst>
          </p:cNvPr>
          <p:cNvSpPr txBox="1"/>
          <p:nvPr/>
        </p:nvSpPr>
        <p:spPr>
          <a:xfrm>
            <a:off x="9546948" y="414751"/>
            <a:ext cx="2377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avors standard vehicl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5F43EC09-8CE5-BC92-794A-E8E71D403B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5196823"/>
              </p:ext>
            </p:extLst>
          </p:nvPr>
        </p:nvGraphicFramePr>
        <p:xfrm>
          <a:off x="6353888" y="1257491"/>
          <a:ext cx="6338351" cy="57041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27581" progId="Prism9.Document">
                  <p:embed/>
                </p:oleObj>
              </mc:Choice>
              <mc:Fallback>
                <p:oleObj name="Prism 9" r:id="rId3" imgW="2697137" imgH="2427581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5F43EC09-8CE5-BC92-794A-E8E71D403B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53888" y="1257491"/>
                        <a:ext cx="6338351" cy="57041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95160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5</TotalTime>
  <Words>650</Words>
  <Application>Microsoft Office PowerPoint</Application>
  <PresentationFormat>ワイド画面</PresentationFormat>
  <Paragraphs>130</Paragraphs>
  <Slides>5</Slides>
  <Notes>5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康 大野</dc:creator>
  <cp:lastModifiedBy>雄康 大野</cp:lastModifiedBy>
  <cp:revision>10</cp:revision>
  <dcterms:created xsi:type="dcterms:W3CDTF">2023-08-29T12:52:27Z</dcterms:created>
  <dcterms:modified xsi:type="dcterms:W3CDTF">2024-11-12T11:52:48Z</dcterms:modified>
</cp:coreProperties>
</file>